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92" r:id="rId3"/>
    <p:sldId id="291" r:id="rId4"/>
    <p:sldId id="293" r:id="rId5"/>
    <p:sldId id="267" r:id="rId6"/>
    <p:sldId id="294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26DCF79-43E3-4B23-9512-30D1CDD701E0}" v="2" dt="2023-09-27T19:08:3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3" d="100"/>
          <a:sy n="63" d="100"/>
        </p:scale>
        <p:origin x="261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illiams, Michael E." userId="f5ad7e1b-d696-4c6e-92a0-4f7128fa3f05" providerId="ADAL" clId="{726DCF79-43E3-4B23-9512-30D1CDD701E0}"/>
    <pc:docChg chg="undo custSel addSld delSld modSld">
      <pc:chgData name="Williams, Michael E." userId="f5ad7e1b-d696-4c6e-92a0-4f7128fa3f05" providerId="ADAL" clId="{726DCF79-43E3-4B23-9512-30D1CDD701E0}" dt="2023-09-27T20:51:49.281" v="328" actId="1076"/>
      <pc:docMkLst>
        <pc:docMk/>
      </pc:docMkLst>
      <pc:sldChg chg="addSp delSp modSp mod">
        <pc:chgData name="Williams, Michael E." userId="f5ad7e1b-d696-4c6e-92a0-4f7128fa3f05" providerId="ADAL" clId="{726DCF79-43E3-4B23-9512-30D1CDD701E0}" dt="2023-09-27T20:51:49.281" v="328" actId="1076"/>
        <pc:sldMkLst>
          <pc:docMk/>
          <pc:sldMk cId="2235158642" sldId="256"/>
        </pc:sldMkLst>
        <pc:spChg chg="mod">
          <ac:chgData name="Williams, Michael E." userId="f5ad7e1b-d696-4c6e-92a0-4f7128fa3f05" providerId="ADAL" clId="{726DCF79-43E3-4B23-9512-30D1CDD701E0}" dt="2023-09-27T20:51:42.178" v="327" actId="1038"/>
          <ac:spMkLst>
            <pc:docMk/>
            <pc:sldMk cId="2235158642" sldId="256"/>
            <ac:spMk id="13" creationId="{5E59E12B-4D15-376C-7BF8-969CCAEAE84A}"/>
          </ac:spMkLst>
        </pc:spChg>
        <pc:spChg chg="mod">
          <ac:chgData name="Williams, Michael E." userId="f5ad7e1b-d696-4c6e-92a0-4f7128fa3f05" providerId="ADAL" clId="{726DCF79-43E3-4B23-9512-30D1CDD701E0}" dt="2023-09-27T20:51:42.178" v="327" actId="1038"/>
          <ac:spMkLst>
            <pc:docMk/>
            <pc:sldMk cId="2235158642" sldId="256"/>
            <ac:spMk id="14" creationId="{279E0237-1BE4-BE14-7E74-FF772132BE5C}"/>
          </ac:spMkLst>
        </pc:spChg>
        <pc:spChg chg="add mod">
          <ac:chgData name="Williams, Michael E." userId="f5ad7e1b-d696-4c6e-92a0-4f7128fa3f05" providerId="ADAL" clId="{726DCF79-43E3-4B23-9512-30D1CDD701E0}" dt="2023-09-27T20:51:49.281" v="328" actId="1076"/>
          <ac:spMkLst>
            <pc:docMk/>
            <pc:sldMk cId="2235158642" sldId="256"/>
            <ac:spMk id="15" creationId="{39C94F3E-8B49-4490-32B9-71350EE7E3CF}"/>
          </ac:spMkLst>
        </pc:spChg>
        <pc:spChg chg="add del mod">
          <ac:chgData name="Williams, Michael E." userId="f5ad7e1b-d696-4c6e-92a0-4f7128fa3f05" providerId="ADAL" clId="{726DCF79-43E3-4B23-9512-30D1CDD701E0}" dt="2023-09-27T19:49:25.648" v="294" actId="478"/>
          <ac:spMkLst>
            <pc:docMk/>
            <pc:sldMk cId="2235158642" sldId="256"/>
            <ac:spMk id="17" creationId="{337227D5-00D4-0B15-3400-EAC9D65E6463}"/>
          </ac:spMkLst>
        </pc:spChg>
        <pc:picChg chg="mod">
          <ac:chgData name="Williams, Michael E." userId="f5ad7e1b-d696-4c6e-92a0-4f7128fa3f05" providerId="ADAL" clId="{726DCF79-43E3-4B23-9512-30D1CDD701E0}" dt="2023-09-27T20:38:44.211" v="308" actId="1076"/>
          <ac:picMkLst>
            <pc:docMk/>
            <pc:sldMk cId="2235158642" sldId="256"/>
            <ac:picMk id="5" creationId="{792BD0EF-C6B8-1A2A-3F57-7FD8A2FA914F}"/>
          </ac:picMkLst>
        </pc:picChg>
        <pc:picChg chg="mod modCrop">
          <ac:chgData name="Williams, Michael E." userId="f5ad7e1b-d696-4c6e-92a0-4f7128fa3f05" providerId="ADAL" clId="{726DCF79-43E3-4B23-9512-30D1CDD701E0}" dt="2023-09-27T20:38:43.811" v="307" actId="1076"/>
          <ac:picMkLst>
            <pc:docMk/>
            <pc:sldMk cId="2235158642" sldId="256"/>
            <ac:picMk id="7" creationId="{4F880711-29BC-E74A-EB73-F35FD6ADF103}"/>
          </ac:picMkLst>
        </pc:picChg>
        <pc:picChg chg="mod">
          <ac:chgData name="Williams, Michael E." userId="f5ad7e1b-d696-4c6e-92a0-4f7128fa3f05" providerId="ADAL" clId="{726DCF79-43E3-4B23-9512-30D1CDD701E0}" dt="2023-09-27T20:38:42.859" v="304" actId="1076"/>
          <ac:picMkLst>
            <pc:docMk/>
            <pc:sldMk cId="2235158642" sldId="256"/>
            <ac:picMk id="8" creationId="{53083D61-B816-DDB4-F712-3F9650EFE27D}"/>
          </ac:picMkLst>
        </pc:picChg>
        <pc:picChg chg="mod">
          <ac:chgData name="Williams, Michael E." userId="f5ad7e1b-d696-4c6e-92a0-4f7128fa3f05" providerId="ADAL" clId="{726DCF79-43E3-4B23-9512-30D1CDD701E0}" dt="2023-09-27T20:51:42.178" v="327" actId="1038"/>
          <ac:picMkLst>
            <pc:docMk/>
            <pc:sldMk cId="2235158642" sldId="256"/>
            <ac:picMk id="11" creationId="{CE3B5A6F-0181-8E07-6789-4CD55028C38C}"/>
          </ac:picMkLst>
        </pc:picChg>
        <pc:picChg chg="mod">
          <ac:chgData name="Williams, Michael E." userId="f5ad7e1b-d696-4c6e-92a0-4f7128fa3f05" providerId="ADAL" clId="{726DCF79-43E3-4B23-9512-30D1CDD701E0}" dt="2023-09-27T20:51:42.178" v="327" actId="1038"/>
          <ac:picMkLst>
            <pc:docMk/>
            <pc:sldMk cId="2235158642" sldId="256"/>
            <ac:picMk id="12" creationId="{D2A7B468-9308-84E3-6833-A37EB7381F73}"/>
          </ac:picMkLst>
        </pc:picChg>
      </pc:sldChg>
      <pc:sldChg chg="modSp add mod">
        <pc:chgData name="Williams, Michael E." userId="f5ad7e1b-d696-4c6e-92a0-4f7128fa3f05" providerId="ADAL" clId="{726DCF79-43E3-4B23-9512-30D1CDD701E0}" dt="2023-09-27T19:32:16.800" v="291" actId="20577"/>
        <pc:sldMkLst>
          <pc:docMk/>
          <pc:sldMk cId="2365391481" sldId="267"/>
        </pc:sldMkLst>
        <pc:spChg chg="mod">
          <ac:chgData name="Williams, Michael E." userId="f5ad7e1b-d696-4c6e-92a0-4f7128fa3f05" providerId="ADAL" clId="{726DCF79-43E3-4B23-9512-30D1CDD701E0}" dt="2023-09-27T19:09:01.270" v="10" actId="20577"/>
          <ac:spMkLst>
            <pc:docMk/>
            <pc:sldMk cId="2365391481" sldId="267"/>
            <ac:spMk id="14" creationId="{C4B9F31C-9EBE-164D-8942-72E6E3DCC484}"/>
          </ac:spMkLst>
        </pc:spChg>
        <pc:spChg chg="mod">
          <ac:chgData name="Williams, Michael E." userId="f5ad7e1b-d696-4c6e-92a0-4f7128fa3f05" providerId="ADAL" clId="{726DCF79-43E3-4B23-9512-30D1CDD701E0}" dt="2023-09-27T19:32:13.320" v="289" actId="20577"/>
          <ac:spMkLst>
            <pc:docMk/>
            <pc:sldMk cId="2365391481" sldId="267"/>
            <ac:spMk id="18" creationId="{FE6D331D-951E-4600-817C-64DD73B21D58}"/>
          </ac:spMkLst>
        </pc:spChg>
        <pc:spChg chg="mod">
          <ac:chgData name="Williams, Michael E." userId="f5ad7e1b-d696-4c6e-92a0-4f7128fa3f05" providerId="ADAL" clId="{726DCF79-43E3-4B23-9512-30D1CDD701E0}" dt="2023-09-27T19:32:16.800" v="291" actId="20577"/>
          <ac:spMkLst>
            <pc:docMk/>
            <pc:sldMk cId="2365391481" sldId="267"/>
            <ac:spMk id="19" creationId="{00CABA4F-C92C-4563-9E0B-889ACD3C663D}"/>
          </ac:spMkLst>
        </pc:spChg>
      </pc:sldChg>
      <pc:sldChg chg="modSp add mod">
        <pc:chgData name="Williams, Michael E." userId="f5ad7e1b-d696-4c6e-92a0-4f7128fa3f05" providerId="ADAL" clId="{726DCF79-43E3-4B23-9512-30D1CDD701E0}" dt="2023-09-27T19:20:25.026" v="287" actId="20577"/>
        <pc:sldMkLst>
          <pc:docMk/>
          <pc:sldMk cId="3394590215" sldId="291"/>
        </pc:sldMkLst>
        <pc:spChg chg="mod">
          <ac:chgData name="Williams, Michael E." userId="f5ad7e1b-d696-4c6e-92a0-4f7128fa3f05" providerId="ADAL" clId="{726DCF79-43E3-4B23-9512-30D1CDD701E0}" dt="2023-09-27T19:20:25.026" v="287" actId="20577"/>
          <ac:spMkLst>
            <pc:docMk/>
            <pc:sldMk cId="3394590215" sldId="291"/>
            <ac:spMk id="5" creationId="{0982F724-5CDB-B7E7-936C-C5DE33E823AD}"/>
          </ac:spMkLst>
        </pc:spChg>
        <pc:spChg chg="mod">
          <ac:chgData name="Williams, Michael E." userId="f5ad7e1b-d696-4c6e-92a0-4f7128fa3f05" providerId="ADAL" clId="{726DCF79-43E3-4B23-9512-30D1CDD701E0}" dt="2023-09-27T19:19:35.789" v="265" actId="20577"/>
          <ac:spMkLst>
            <pc:docMk/>
            <pc:sldMk cId="3394590215" sldId="291"/>
            <ac:spMk id="6" creationId="{9D8AE8DE-CFAD-AD57-AD4B-1803733DA925}"/>
          </ac:spMkLst>
        </pc:spChg>
        <pc:spChg chg="mod">
          <ac:chgData name="Williams, Michael E." userId="f5ad7e1b-d696-4c6e-92a0-4f7128fa3f05" providerId="ADAL" clId="{726DCF79-43E3-4B23-9512-30D1CDD701E0}" dt="2023-09-27T19:19:37.953" v="267" actId="20577"/>
          <ac:spMkLst>
            <pc:docMk/>
            <pc:sldMk cId="3394590215" sldId="291"/>
            <ac:spMk id="7" creationId="{23E1A32B-22C1-29D4-8B9D-DD01B271F920}"/>
          </ac:spMkLst>
        </pc:spChg>
        <pc:spChg chg="mod">
          <ac:chgData name="Williams, Michael E." userId="f5ad7e1b-d696-4c6e-92a0-4f7128fa3f05" providerId="ADAL" clId="{726DCF79-43E3-4B23-9512-30D1CDD701E0}" dt="2023-09-27T19:19:41.893" v="269" actId="20577"/>
          <ac:spMkLst>
            <pc:docMk/>
            <pc:sldMk cId="3394590215" sldId="291"/>
            <ac:spMk id="10" creationId="{1A1215B8-2286-CD11-6B27-DFAD001BA865}"/>
          </ac:spMkLst>
        </pc:spChg>
        <pc:spChg chg="mod">
          <ac:chgData name="Williams, Michael E." userId="f5ad7e1b-d696-4c6e-92a0-4f7128fa3f05" providerId="ADAL" clId="{726DCF79-43E3-4B23-9512-30D1CDD701E0}" dt="2023-09-27T19:19:46.930" v="273" actId="20577"/>
          <ac:spMkLst>
            <pc:docMk/>
            <pc:sldMk cId="3394590215" sldId="291"/>
            <ac:spMk id="14" creationId="{BD78C590-A221-CA63-95D9-C0BD9F8C7916}"/>
          </ac:spMkLst>
        </pc:spChg>
        <pc:spChg chg="mod">
          <ac:chgData name="Williams, Michael E." userId="f5ad7e1b-d696-4c6e-92a0-4f7128fa3f05" providerId="ADAL" clId="{726DCF79-43E3-4B23-9512-30D1CDD701E0}" dt="2023-09-27T19:19:50.797" v="275" actId="20577"/>
          <ac:spMkLst>
            <pc:docMk/>
            <pc:sldMk cId="3394590215" sldId="291"/>
            <ac:spMk id="15" creationId="{86E3D63F-6311-5A73-CC3B-04F9246E996F}"/>
          </ac:spMkLst>
        </pc:spChg>
        <pc:spChg chg="mod">
          <ac:chgData name="Williams, Michael E." userId="f5ad7e1b-d696-4c6e-92a0-4f7128fa3f05" providerId="ADAL" clId="{726DCF79-43E3-4B23-9512-30D1CDD701E0}" dt="2023-09-27T19:19:44.382" v="271" actId="20577"/>
          <ac:spMkLst>
            <pc:docMk/>
            <pc:sldMk cId="3394590215" sldId="291"/>
            <ac:spMk id="17" creationId="{2EE94BF6-2116-DB4A-AA07-F077EDCDD1CD}"/>
          </ac:spMkLst>
        </pc:spChg>
      </pc:sldChg>
      <pc:sldChg chg="modSp add mod">
        <pc:chgData name="Williams, Michael E." userId="f5ad7e1b-d696-4c6e-92a0-4f7128fa3f05" providerId="ADAL" clId="{726DCF79-43E3-4B23-9512-30D1CDD701E0}" dt="2023-09-27T19:08:42.428" v="4" actId="20577"/>
        <pc:sldMkLst>
          <pc:docMk/>
          <pc:sldMk cId="2753489636" sldId="292"/>
        </pc:sldMkLst>
        <pc:spChg chg="mod">
          <ac:chgData name="Williams, Michael E." userId="f5ad7e1b-d696-4c6e-92a0-4f7128fa3f05" providerId="ADAL" clId="{726DCF79-43E3-4B23-9512-30D1CDD701E0}" dt="2023-09-27T19:08:42.428" v="4" actId="20577"/>
          <ac:spMkLst>
            <pc:docMk/>
            <pc:sldMk cId="2753489636" sldId="292"/>
            <ac:spMk id="10" creationId="{7F59D903-8444-0642-5D1D-E3EC935C261F}"/>
          </ac:spMkLst>
        </pc:spChg>
      </pc:sldChg>
      <pc:sldChg chg="modSp add mod">
        <pc:chgData name="Williams, Michael E." userId="f5ad7e1b-d696-4c6e-92a0-4f7128fa3f05" providerId="ADAL" clId="{726DCF79-43E3-4B23-9512-30D1CDD701E0}" dt="2023-09-27T19:08:58.004" v="8" actId="20577"/>
        <pc:sldMkLst>
          <pc:docMk/>
          <pc:sldMk cId="1125728656" sldId="293"/>
        </pc:sldMkLst>
        <pc:spChg chg="mod">
          <ac:chgData name="Williams, Michael E." userId="f5ad7e1b-d696-4c6e-92a0-4f7128fa3f05" providerId="ADAL" clId="{726DCF79-43E3-4B23-9512-30D1CDD701E0}" dt="2023-09-27T19:08:58.004" v="8" actId="20577"/>
          <ac:spMkLst>
            <pc:docMk/>
            <pc:sldMk cId="1125728656" sldId="293"/>
            <ac:spMk id="7" creationId="{AFFCE8CC-C2D9-7ECB-F9AD-48A4E5EA915F}"/>
          </ac:spMkLst>
        </pc:spChg>
      </pc:sldChg>
      <pc:sldChg chg="modSp add del mod">
        <pc:chgData name="Williams, Michael E." userId="f5ad7e1b-d696-4c6e-92a0-4f7128fa3f05" providerId="ADAL" clId="{726DCF79-43E3-4B23-9512-30D1CDD701E0}" dt="2023-09-27T20:39:02.989" v="309" actId="47"/>
        <pc:sldMkLst>
          <pc:docMk/>
          <pc:sldMk cId="1658816118" sldId="296"/>
        </pc:sldMkLst>
        <pc:spChg chg="mod">
          <ac:chgData name="Williams, Michael E." userId="f5ad7e1b-d696-4c6e-92a0-4f7128fa3f05" providerId="ADAL" clId="{726DCF79-43E3-4B23-9512-30D1CDD701E0}" dt="2023-09-27T19:09:05.479" v="12" actId="20577"/>
          <ac:spMkLst>
            <pc:docMk/>
            <pc:sldMk cId="1658816118" sldId="296"/>
            <ac:spMk id="2" creationId="{17464063-8989-412F-DC34-68AFA80D6AFA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4DA3-E51C-4EC6-AA14-47FF174B8574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5C0C5-34A7-4B79-8527-BE0FF7B49D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839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4DA3-E51C-4EC6-AA14-47FF174B8574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5C0C5-34A7-4B79-8527-BE0FF7B49D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71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4DA3-E51C-4EC6-AA14-47FF174B8574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5C0C5-34A7-4B79-8527-BE0FF7B49D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013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4DA3-E51C-4EC6-AA14-47FF174B8574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5C0C5-34A7-4B79-8527-BE0FF7B49D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7966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4DA3-E51C-4EC6-AA14-47FF174B8574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5C0C5-34A7-4B79-8527-BE0FF7B49D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6479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4DA3-E51C-4EC6-AA14-47FF174B8574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5C0C5-34A7-4B79-8527-BE0FF7B49D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430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4DA3-E51C-4EC6-AA14-47FF174B8574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5C0C5-34A7-4B79-8527-BE0FF7B49D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872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4DA3-E51C-4EC6-AA14-47FF174B8574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5C0C5-34A7-4B79-8527-BE0FF7B49D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589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4DA3-E51C-4EC6-AA14-47FF174B8574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5C0C5-34A7-4B79-8527-BE0FF7B49D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019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4DA3-E51C-4EC6-AA14-47FF174B8574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5C0C5-34A7-4B79-8527-BE0FF7B49D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227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204DA3-E51C-4EC6-AA14-47FF174B8574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5C0C5-34A7-4B79-8527-BE0FF7B49D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25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204DA3-E51C-4EC6-AA14-47FF174B8574}" type="datetimeFigureOut">
              <a:rPr lang="en-US" smtClean="0"/>
              <a:t>7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95C0C5-34A7-4B79-8527-BE0FF7B49D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431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emf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7" Type="http://schemas.openxmlformats.org/officeDocument/2006/relationships/image" Target="../media/image19.emf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18.emf"/><Relationship Id="rId4" Type="http://schemas.openxmlformats.org/officeDocument/2006/relationships/image" Target="../media/image17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3" Type="http://schemas.openxmlformats.org/officeDocument/2006/relationships/image" Target="../media/image21.emf"/><Relationship Id="rId7" Type="http://schemas.openxmlformats.org/officeDocument/2006/relationships/image" Target="../media/image25.emf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emf"/><Relationship Id="rId5" Type="http://schemas.openxmlformats.org/officeDocument/2006/relationships/image" Target="../media/image23.emf"/><Relationship Id="rId10" Type="http://schemas.openxmlformats.org/officeDocument/2006/relationships/image" Target="../media/image28.emf"/><Relationship Id="rId4" Type="http://schemas.openxmlformats.org/officeDocument/2006/relationships/image" Target="../media/image22.emf"/><Relationship Id="rId9" Type="http://schemas.openxmlformats.org/officeDocument/2006/relationships/image" Target="../media/image2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92BD0EF-C6B8-1A2A-3F57-7FD8A2FA91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496" y="231648"/>
            <a:ext cx="1886556" cy="291388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F880711-29BC-E74A-EB73-F35FD6ADF1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37789" y="231648"/>
            <a:ext cx="1366232" cy="240182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3083D61-B816-DDB4-F712-3F9650EFE27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42144" y="207264"/>
            <a:ext cx="1390805" cy="227990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75BA5E2-C04D-78C8-FE64-238DAB7A87DE}"/>
              </a:ext>
            </a:extLst>
          </p:cNvPr>
          <p:cNvSpPr txBox="1"/>
          <p:nvPr/>
        </p:nvSpPr>
        <p:spPr>
          <a:xfrm>
            <a:off x="0" y="0"/>
            <a:ext cx="2664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54C8150-23CC-6AC0-61C3-1DEA925FB020}"/>
              </a:ext>
            </a:extLst>
          </p:cNvPr>
          <p:cNvSpPr txBox="1"/>
          <p:nvPr/>
        </p:nvSpPr>
        <p:spPr>
          <a:xfrm>
            <a:off x="25286" y="2804160"/>
            <a:ext cx="2616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B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CE3B5A6F-0181-8E07-6789-4CD55028C38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57812" y="3024100"/>
            <a:ext cx="1366233" cy="114616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2A7B468-9308-84E3-6833-A37EB7381F7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91581" y="3024100"/>
            <a:ext cx="1366232" cy="1146168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5E59E12B-4D15-376C-7BF8-969CCAEAE84A}"/>
              </a:ext>
            </a:extLst>
          </p:cNvPr>
          <p:cNvSpPr txBox="1"/>
          <p:nvPr/>
        </p:nvSpPr>
        <p:spPr>
          <a:xfrm>
            <a:off x="2157814" y="4170268"/>
            <a:ext cx="136623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Primary Omentum-Derived </a:t>
            </a:r>
          </a:p>
          <a:p>
            <a:pPr algn="ctr"/>
            <a:r>
              <a:rPr lang="en-GB" sz="1000" dirty="0"/>
              <a:t>Adipocyte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79E0237-1BE4-BE14-7E74-FF772132BE5C}"/>
              </a:ext>
            </a:extLst>
          </p:cNvPr>
          <p:cNvSpPr txBox="1"/>
          <p:nvPr/>
        </p:nvSpPr>
        <p:spPr>
          <a:xfrm>
            <a:off x="881882" y="4170268"/>
            <a:ext cx="11451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dirty="0"/>
              <a:t>Primary Omental Stromal Cell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9C94F3E-8B49-4490-32B9-71350EE7E3CF}"/>
              </a:ext>
            </a:extLst>
          </p:cNvPr>
          <p:cNvSpPr txBox="1"/>
          <p:nvPr/>
        </p:nvSpPr>
        <p:spPr>
          <a:xfrm>
            <a:off x="104099" y="4707200"/>
            <a:ext cx="6512767" cy="7562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1. Adipocytes in Primary Omental Samples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he presence of primary adipocytes in patient derived samples was validated by ELISA for adiponectin (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 and oil red O staining of omentum-derived cells (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. Scale bar = 100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m.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51586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05B8577A-418F-5CDC-8DB1-1DC5BA347D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08493" y="599556"/>
            <a:ext cx="3079747" cy="226041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657F7FE-8065-5CF0-BBE7-ACC29D862C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9760" y="599556"/>
            <a:ext cx="2859240" cy="226041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7F59D903-8444-0642-5D1D-E3EC935C261F}"/>
              </a:ext>
            </a:extLst>
          </p:cNvPr>
          <p:cNvSpPr txBox="1"/>
          <p:nvPr/>
        </p:nvSpPr>
        <p:spPr>
          <a:xfrm>
            <a:off x="172616" y="2936401"/>
            <a:ext cx="6512767" cy="7562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. EOC co-culture with undifferentiated ADSCs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he impact of undifferentiated adipocyte-derived stem cells on EOC activity and response to PTX therapy was assessed by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Titer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Glo Luminescent Cell Viability Assay. Bar plots show mean + SD, n=3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34896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EAD4EC7-0BDB-B70C-C904-3B493DC97F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01051" y="459579"/>
            <a:ext cx="2796584" cy="93162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E2F320D-59F1-0480-99A0-DFC277310B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7225" y="1601043"/>
            <a:ext cx="1689854" cy="139957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982F724-5CDB-B7E7-936C-C5DE33E823AD}"/>
              </a:ext>
            </a:extLst>
          </p:cNvPr>
          <p:cNvSpPr txBox="1"/>
          <p:nvPr/>
        </p:nvSpPr>
        <p:spPr>
          <a:xfrm>
            <a:off x="93037" y="5992151"/>
            <a:ext cx="6512767" cy="2602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3. Direct co-culture with SKOV-3/LUC firefly luciferase assay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Direct co-cultures comprising ADSC-derived adipocyte spheroids and luciferase-expressing SKOV-3 cells (SKOV-3/LUC) were established (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. Differentiation of ADSC to mature adipocytes was visualized via BODIPY staining of lipid droplets (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. Luciferase activity (Pierce Firefly One-Step Luc Glow Assay) in SKOV-3/LUC spheroid culture was compared to SKOV-3 without luciferase gene as well as undifferentiated ADSCs and ADSC-derived adipocytes (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. Luciferase activity in spheroids generated from serial dilution of SKOV-3/LUC cells was compared with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Titer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-Glo Luminescent Cell Viability Assay to ensure luciferase activity corresponded to SKOV-3/LUC cell number. (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. The impact of direct coculture with adipocytes on SKOV-3/LUC cells was assessed via Pierce Firefly One-Step Luc Glow Assay (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. Luciferase activity relative to untreated monoculture is displayed in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, while change in luciferase activity following treatment for each group is displayed as % survival in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Bar plots show mean + SD, n=3. *p&lt;0.05, **p&lt;0.01 as indicated (Student’s t-test).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D8AE8DE-CFAD-AD57-AD4B-1803733DA925}"/>
              </a:ext>
            </a:extLst>
          </p:cNvPr>
          <p:cNvSpPr txBox="1"/>
          <p:nvPr/>
        </p:nvSpPr>
        <p:spPr>
          <a:xfrm>
            <a:off x="400889" y="89415"/>
            <a:ext cx="4349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3E1A32B-22C1-29D4-8B9D-DD01B271F920}"/>
              </a:ext>
            </a:extLst>
          </p:cNvPr>
          <p:cNvSpPr txBox="1"/>
          <p:nvPr/>
        </p:nvSpPr>
        <p:spPr>
          <a:xfrm>
            <a:off x="3541735" y="89415"/>
            <a:ext cx="5435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1B1B7AAA-12A2-D09B-F99A-51DC128D2F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6570" y="3139859"/>
            <a:ext cx="2733112" cy="214038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F571C4F-BA08-F08B-D524-F035D39DEE1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15398" y="3218178"/>
            <a:ext cx="2997217" cy="206487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A1215B8-2286-CD11-6B27-DFAD001BA865}"/>
              </a:ext>
            </a:extLst>
          </p:cNvPr>
          <p:cNvSpPr txBox="1"/>
          <p:nvPr/>
        </p:nvSpPr>
        <p:spPr>
          <a:xfrm>
            <a:off x="623617" y="1480707"/>
            <a:ext cx="5435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D9E4A91-359F-7819-A116-84CE706C7825}"/>
              </a:ext>
            </a:extLst>
          </p:cNvPr>
          <p:cNvSpPr txBox="1"/>
          <p:nvPr/>
        </p:nvSpPr>
        <p:spPr>
          <a:xfrm>
            <a:off x="3962898" y="256102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DAPI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1C9F902-AD1E-D131-93FF-F9556A5A804A}"/>
              </a:ext>
            </a:extLst>
          </p:cNvPr>
          <p:cNvSpPr txBox="1"/>
          <p:nvPr/>
        </p:nvSpPr>
        <p:spPr>
          <a:xfrm>
            <a:off x="4834202" y="224939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BODIPY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7F15ABF-4E30-0827-E748-31BED3D90DFD}"/>
              </a:ext>
            </a:extLst>
          </p:cNvPr>
          <p:cNvSpPr txBox="1"/>
          <p:nvPr/>
        </p:nvSpPr>
        <p:spPr>
          <a:xfrm>
            <a:off x="5819320" y="241933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Merg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D78C590-A221-CA63-95D9-C0BD9F8C7916}"/>
              </a:ext>
            </a:extLst>
          </p:cNvPr>
          <p:cNvSpPr txBox="1"/>
          <p:nvPr/>
        </p:nvSpPr>
        <p:spPr>
          <a:xfrm>
            <a:off x="256748" y="3000616"/>
            <a:ext cx="5435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6E3D63F-6311-5A73-CC3B-04F9246E996F}"/>
              </a:ext>
            </a:extLst>
          </p:cNvPr>
          <p:cNvSpPr txBox="1"/>
          <p:nvPr/>
        </p:nvSpPr>
        <p:spPr>
          <a:xfrm>
            <a:off x="2901132" y="3079653"/>
            <a:ext cx="5435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7FA7B4B7-175E-362E-2B80-64DD332D518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10587" y="227914"/>
            <a:ext cx="2204812" cy="1189989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2EE94BF6-2116-DB4A-AA07-F077EDCDD1CD}"/>
              </a:ext>
            </a:extLst>
          </p:cNvPr>
          <p:cNvSpPr txBox="1"/>
          <p:nvPr/>
        </p:nvSpPr>
        <p:spPr>
          <a:xfrm>
            <a:off x="2662643" y="1527153"/>
            <a:ext cx="5435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CD76D515-879F-05A7-CF5C-549B1197D3B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9449"/>
          <a:stretch/>
        </p:blipFill>
        <p:spPr>
          <a:xfrm>
            <a:off x="2854766" y="1468923"/>
            <a:ext cx="2016692" cy="16638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45902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CDF26994-ECBD-86AC-E96E-709C22019B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6910" y="295275"/>
            <a:ext cx="1760566" cy="226695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FFCE8CC-C2D9-7ECB-F9AD-48A4E5EA915F}"/>
              </a:ext>
            </a:extLst>
          </p:cNvPr>
          <p:cNvSpPr txBox="1"/>
          <p:nvPr/>
        </p:nvSpPr>
        <p:spPr>
          <a:xfrm>
            <a:off x="172616" y="2562225"/>
            <a:ext cx="6512767" cy="5254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4. Paclitaxel treatment of adipocytes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Mature ADSC-derived adipocytes were treated with 500nM PTX for 72H and population viability assessed by MTT assay. Bar plots show mean + SD, n=3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1257286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9A4816C1-58B3-46FB-B4BE-78684FD3B819}"/>
              </a:ext>
            </a:extLst>
          </p:cNvPr>
          <p:cNvCxnSpPr/>
          <p:nvPr/>
        </p:nvCxnSpPr>
        <p:spPr>
          <a:xfrm>
            <a:off x="1813412" y="756472"/>
            <a:ext cx="1239252" cy="0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F98E4249-39A2-4B9F-B17D-DACA4402F686}"/>
              </a:ext>
            </a:extLst>
          </p:cNvPr>
          <p:cNvCxnSpPr/>
          <p:nvPr/>
        </p:nvCxnSpPr>
        <p:spPr>
          <a:xfrm>
            <a:off x="4421882" y="744433"/>
            <a:ext cx="1239252" cy="0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8D25BB3F-176A-4C55-9FF8-5B1096A43530}"/>
              </a:ext>
            </a:extLst>
          </p:cNvPr>
          <p:cNvSpPr txBox="1"/>
          <p:nvPr/>
        </p:nvSpPr>
        <p:spPr>
          <a:xfrm>
            <a:off x="1881893" y="455688"/>
            <a:ext cx="11022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HGSOC OT-CM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60B720D-501B-4013-8D62-03F27EC2C637}"/>
              </a:ext>
            </a:extLst>
          </p:cNvPr>
          <p:cNvSpPr txBox="1"/>
          <p:nvPr/>
        </p:nvSpPr>
        <p:spPr>
          <a:xfrm>
            <a:off x="4219054" y="444785"/>
            <a:ext cx="15007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/>
              <a:t>Ovarian Mass OT-CM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6DF4AA8-8090-4D68-A647-11C8178420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1891" y="805967"/>
            <a:ext cx="2544267" cy="330812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EC1A548-5459-4D99-A3C3-D66D1CF80ED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19775" y="758424"/>
            <a:ext cx="2555061" cy="335676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E3667524-C3A7-44D3-8A6F-5CF611F3DE17}"/>
              </a:ext>
            </a:extLst>
          </p:cNvPr>
          <p:cNvSpPr txBox="1"/>
          <p:nvPr/>
        </p:nvSpPr>
        <p:spPr>
          <a:xfrm rot="16200000">
            <a:off x="514982" y="1496862"/>
            <a:ext cx="8089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err="1"/>
              <a:t>Exosomes</a:t>
            </a:r>
            <a:endParaRPr lang="en-GB" sz="1200"/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33696339-0DF7-4156-A9B8-6080E692AE7A}"/>
              </a:ext>
            </a:extLst>
          </p:cNvPr>
          <p:cNvCxnSpPr/>
          <p:nvPr/>
        </p:nvCxnSpPr>
        <p:spPr>
          <a:xfrm flipV="1">
            <a:off x="1084908" y="1090246"/>
            <a:ext cx="0" cy="965881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6C9B57F3-8FF4-4B2E-9795-4002845EBEFB}"/>
              </a:ext>
            </a:extLst>
          </p:cNvPr>
          <p:cNvSpPr txBox="1"/>
          <p:nvPr/>
        </p:nvSpPr>
        <p:spPr>
          <a:xfrm rot="16200000">
            <a:off x="419154" y="3037069"/>
            <a:ext cx="10212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err="1"/>
              <a:t>Exo</a:t>
            </a:r>
            <a:r>
              <a:rPr lang="en-GB" sz="1200"/>
              <a:t>-Depleted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7796DB7F-4321-4CC4-A1BC-C7544125AE8B}"/>
              </a:ext>
            </a:extLst>
          </p:cNvPr>
          <p:cNvCxnSpPr/>
          <p:nvPr/>
        </p:nvCxnSpPr>
        <p:spPr>
          <a:xfrm flipV="1">
            <a:off x="1085764" y="2724309"/>
            <a:ext cx="0" cy="965881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C4B9F31C-9EBE-164D-8942-72E6E3DCC484}"/>
              </a:ext>
            </a:extLst>
          </p:cNvPr>
          <p:cNvSpPr txBox="1"/>
          <p:nvPr/>
        </p:nvSpPr>
        <p:spPr>
          <a:xfrm>
            <a:off x="162467" y="6694890"/>
            <a:ext cx="6512767" cy="9871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5. Characterisation of OT-CM-derived Exosomes. (A)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Particle size distribution in exosome-isolated and exosome-depleted treatments as measured by dynamic light scattering (DLS).  (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 Exosome specific markers were identified in exosome isolated-and depleted treatments. Levels of makers CD63, CD9 and CD81 were normalised to particle number as determined by nanoparticle tracking analysis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1A233DA-3F85-49FB-8D65-9ABE48EC7E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4090" y="4227497"/>
            <a:ext cx="1960004" cy="235508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FF850B3-CD3C-4B35-BDDA-B9D2745D754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58189" y="4227497"/>
            <a:ext cx="1955975" cy="2394113"/>
          </a:xfrm>
          <a:prstGeom prst="rect">
            <a:avLst/>
          </a:prstGeom>
        </p:spPr>
      </p:pic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7D8FA8A0-9786-4FAA-B8AA-C7AC889A451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47033" y="4227497"/>
          <a:ext cx="2028201" cy="2394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6" imgW="3695713" imgH="4362186" progId="Prism7.Document">
                  <p:embed/>
                </p:oleObj>
              </mc:Choice>
              <mc:Fallback>
                <p:oleObj name="Prism 7" r:id="rId6" imgW="3695713" imgH="4362186" progId="Prism7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7D8FA8A0-9786-4FAA-B8AA-C7AC889A451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647033" y="4227497"/>
                        <a:ext cx="2028201" cy="2394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FE6D331D-951E-4600-817C-64DD73B21D58}"/>
              </a:ext>
            </a:extLst>
          </p:cNvPr>
          <p:cNvSpPr txBox="1"/>
          <p:nvPr/>
        </p:nvSpPr>
        <p:spPr>
          <a:xfrm>
            <a:off x="525584" y="636223"/>
            <a:ext cx="4954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0CABA4F-C92C-4563-9E0B-889ACD3C663D}"/>
              </a:ext>
            </a:extLst>
          </p:cNvPr>
          <p:cNvSpPr txBox="1"/>
          <p:nvPr/>
        </p:nvSpPr>
        <p:spPr>
          <a:xfrm>
            <a:off x="533227" y="4192202"/>
            <a:ext cx="4954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53914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C87075D5-D3AE-B001-A8D8-B059071DC6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9604" y="140209"/>
            <a:ext cx="1505046" cy="203584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CFEC076-F384-4245-5758-3D5D9AB4AF8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8056" y="140208"/>
            <a:ext cx="1505046" cy="2035844"/>
          </a:xfrm>
          <a:prstGeom prst="rect">
            <a:avLst/>
          </a:prstGeom>
          <a:ln>
            <a:noFill/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99A39D5-8FAA-48FE-5CC1-CF0102C88A42}"/>
              </a:ext>
            </a:extLst>
          </p:cNvPr>
          <p:cNvSpPr txBox="1"/>
          <p:nvPr/>
        </p:nvSpPr>
        <p:spPr>
          <a:xfrm>
            <a:off x="0" y="0"/>
            <a:ext cx="239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0350F8B7-F287-2D67-54CD-2CF0169F2A7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43033" y="140207"/>
            <a:ext cx="1538641" cy="203584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2E9B4D1-1B47-15B3-3F8E-4FD3ABCB4B1A}"/>
              </a:ext>
            </a:extLst>
          </p:cNvPr>
          <p:cNvSpPr txBox="1"/>
          <p:nvPr/>
        </p:nvSpPr>
        <p:spPr>
          <a:xfrm>
            <a:off x="39485" y="2111551"/>
            <a:ext cx="239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EDC61A3-E7D2-3A42-961D-45BDFE5E7B10}"/>
              </a:ext>
            </a:extLst>
          </p:cNvPr>
          <p:cNvSpPr txBox="1"/>
          <p:nvPr/>
        </p:nvSpPr>
        <p:spPr>
          <a:xfrm rot="16200000">
            <a:off x="-322192" y="903465"/>
            <a:ext cx="10734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HGSO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0F99F7E-735D-B574-4D22-446D58715F95}"/>
              </a:ext>
            </a:extLst>
          </p:cNvPr>
          <p:cNvSpPr txBox="1"/>
          <p:nvPr/>
        </p:nvSpPr>
        <p:spPr>
          <a:xfrm rot="16200000">
            <a:off x="-403494" y="2714521"/>
            <a:ext cx="133085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Benign Mass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BCC2D422-B95F-38EF-C9A6-008B7AC207A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5345" y="2126793"/>
            <a:ext cx="1505046" cy="2035844"/>
          </a:xfrm>
          <a:prstGeom prst="rect">
            <a:avLst/>
          </a:prstGeom>
          <a:ln>
            <a:noFill/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E737554-11EE-B0D2-8A01-95EF820E58D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99194" y="2126793"/>
            <a:ext cx="1505046" cy="2035844"/>
          </a:xfrm>
          <a:prstGeom prst="rect">
            <a:avLst/>
          </a:prstGeom>
          <a:ln>
            <a:noFill/>
          </a:ln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6A36A48-4AEE-7704-09ED-60C1F2E12F1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93444" y="2126791"/>
            <a:ext cx="1505046" cy="2035844"/>
          </a:xfrm>
          <a:prstGeom prst="rect">
            <a:avLst/>
          </a:prstGeom>
          <a:ln>
            <a:noFill/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2A504A27-4DEE-9F98-94C0-5EAC350DBD6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75062" y="4148784"/>
            <a:ext cx="1486192" cy="2218086"/>
          </a:xfrm>
          <a:prstGeom prst="rect">
            <a:avLst/>
          </a:prstGeom>
          <a:ln>
            <a:noFill/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EA2A004A-88C2-97E3-F377-0BE649CAAAC2}"/>
              </a:ext>
            </a:extLst>
          </p:cNvPr>
          <p:cNvSpPr txBox="1"/>
          <p:nvPr/>
        </p:nvSpPr>
        <p:spPr>
          <a:xfrm>
            <a:off x="46442" y="4170647"/>
            <a:ext cx="239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885E2905-ED67-BE66-FB8F-27D9D06F6CA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54224" y="4148784"/>
            <a:ext cx="1490911" cy="2225128"/>
          </a:xfrm>
          <a:prstGeom prst="rect">
            <a:avLst/>
          </a:prstGeom>
          <a:ln>
            <a:noFill/>
          </a:ln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3F21D50C-C3FF-0678-2FCB-9E7FE49358E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398527" y="4180730"/>
            <a:ext cx="1438880" cy="2202822"/>
          </a:xfrm>
          <a:prstGeom prst="rect">
            <a:avLst/>
          </a:prstGeom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5775380-E59B-F587-9614-57097C412D9B}"/>
              </a:ext>
            </a:extLst>
          </p:cNvPr>
          <p:cNvSpPr txBox="1"/>
          <p:nvPr/>
        </p:nvSpPr>
        <p:spPr>
          <a:xfrm>
            <a:off x="119539" y="6373912"/>
            <a:ext cx="6512767" cy="9871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6. Impact of patient-derived exosomes on EOC cell lines and response to therapy. </a:t>
            </a:r>
            <a:r>
              <a:rPr lang="en-GB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ffect of EVs treatments on proliferation of EOC cell lines with EVs isolated from OT-CM derived from patients with HGSOC (</a:t>
            </a:r>
            <a:r>
              <a:rPr lang="en-GB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GB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benign ovarian mass (</a:t>
            </a:r>
            <a:r>
              <a:rPr lang="en-GB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GB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 Change in population viability following 72 hours 50nM paclitaxel treatment was also assessed </a:t>
            </a:r>
            <a:r>
              <a:rPr lang="en-GB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C).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9335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81</TotalTime>
  <Words>479</Words>
  <Application>Microsoft Office PowerPoint</Application>
  <PresentationFormat>A4 Paper (210x297 mm)</PresentationFormat>
  <Paragraphs>31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ouston Methodis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liams, Michael E.</dc:creator>
  <cp:lastModifiedBy>Mike Williams</cp:lastModifiedBy>
  <cp:revision>8</cp:revision>
  <dcterms:created xsi:type="dcterms:W3CDTF">2023-09-27T18:26:39Z</dcterms:created>
  <dcterms:modified xsi:type="dcterms:W3CDTF">2024-07-17T07:24:37Z</dcterms:modified>
</cp:coreProperties>
</file>